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63" d="100"/>
          <a:sy n="63" d="100"/>
        </p:scale>
        <p:origin x="72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2228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87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6108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449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8008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03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945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5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29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88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374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792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png"/><Relationship Id="rId7" Type="http://schemas.openxmlformats.org/officeDocument/2006/relationships/image" Target="../media/image5.jpeg"/><Relationship Id="rId12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png"/><Relationship Id="rId5" Type="http://schemas.openxmlformats.org/officeDocument/2006/relationships/image" Target="../media/image3.jpeg"/><Relationship Id="rId10" Type="http://schemas.microsoft.com/office/2007/relationships/hdphoto" Target="../media/hdphoto2.wdp"/><Relationship Id="rId4" Type="http://schemas.microsoft.com/office/2007/relationships/hdphoto" Target="../media/hdphoto1.wdp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85564" y="4287833"/>
            <a:ext cx="2835000" cy="2016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59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85564" y="1368335"/>
            <a:ext cx="2835000" cy="2016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143409" y="4287833"/>
            <a:ext cx="2835000" cy="2016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143409" y="1368335"/>
            <a:ext cx="2835000" cy="20160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230916" y="4287833"/>
            <a:ext cx="2835000" cy="2016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230916" y="1368335"/>
            <a:ext cx="2835000" cy="2016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59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373071" y="4287833"/>
            <a:ext cx="2835000" cy="201600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373071" y="1368335"/>
            <a:ext cx="2835000" cy="2016000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3211741" y="353380"/>
            <a:ext cx="1141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NICD1</a:t>
            </a:r>
          </a:p>
        </p:txBody>
      </p:sp>
      <p:cxnSp>
        <p:nvCxnSpPr>
          <p:cNvPr id="19" name="Gerader Verbinder 18"/>
          <p:cNvCxnSpPr/>
          <p:nvPr/>
        </p:nvCxnSpPr>
        <p:spPr>
          <a:xfrm>
            <a:off x="1695064" y="663838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2320587" y="660704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408094" y="660704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7692726" y="353380"/>
            <a:ext cx="18678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NICD1/HSF1dn</a:t>
            </a:r>
          </a:p>
        </p:txBody>
      </p:sp>
      <p:cxnSp>
        <p:nvCxnSpPr>
          <p:cNvPr id="23" name="Gerader Verbinder 22"/>
          <p:cNvCxnSpPr/>
          <p:nvPr/>
        </p:nvCxnSpPr>
        <p:spPr>
          <a:xfrm>
            <a:off x="6542626" y="664773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7168149" y="661639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9255656" y="661639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26" name="Textfeld 25"/>
          <p:cNvSpPr txBox="1"/>
          <p:nvPr/>
        </p:nvSpPr>
        <p:spPr>
          <a:xfrm rot="16200000">
            <a:off x="1281080" y="2237835"/>
            <a:ext cx="508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27" name="Textfeld 26"/>
          <p:cNvSpPr txBox="1"/>
          <p:nvPr/>
        </p:nvSpPr>
        <p:spPr>
          <a:xfrm rot="16200000">
            <a:off x="1247418" y="5157334"/>
            <a:ext cx="575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</a:p>
        </p:txBody>
      </p:sp>
      <p:sp>
        <p:nvSpPr>
          <p:cNvPr id="2" name="Textfeld 19">
            <a:extLst>
              <a:ext uri="{FF2B5EF4-FFF2-40B4-BE49-F238E27FC236}">
                <a16:creationId xmlns:a16="http://schemas.microsoft.com/office/drawing/2014/main" id="{C84E08A8-C933-2751-DD94-1C996FD83EE0}"/>
              </a:ext>
            </a:extLst>
          </p:cNvPr>
          <p:cNvSpPr txBox="1"/>
          <p:nvPr/>
        </p:nvSpPr>
        <p:spPr>
          <a:xfrm>
            <a:off x="1259335" y="7903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feld 19">
            <a:extLst>
              <a:ext uri="{FF2B5EF4-FFF2-40B4-BE49-F238E27FC236}">
                <a16:creationId xmlns:a16="http://schemas.microsoft.com/office/drawing/2014/main" id="{EB371FFB-7053-7008-F507-05774F21BF1A}"/>
              </a:ext>
            </a:extLst>
          </p:cNvPr>
          <p:cNvSpPr txBox="1"/>
          <p:nvPr/>
        </p:nvSpPr>
        <p:spPr>
          <a:xfrm>
            <a:off x="6145107" y="7903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08598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C5BF8A-1B7A-3BD6-19D8-AE6B4083E1B0}"/>
              </a:ext>
            </a:extLst>
          </p:cNvPr>
          <p:cNvSpPr txBox="1"/>
          <p:nvPr/>
        </p:nvSpPr>
        <p:spPr>
          <a:xfrm>
            <a:off x="219457" y="394209"/>
            <a:ext cx="11777472" cy="253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Inactivation of HSF1 via HSF1dn injection reduces the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ggressiveness of AKT/NICD1 mouse lesions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Two distinct AKT/NICD1 mouse livers at 5 weeks post hydrodynamic injection are shown. The lesions are characterized by a solid appearance, form small ducts, and are CK19-positive. (B) Two AKT/NICD1/HSF1dn mouse livers at 14 weeks post hydrodynamic injection. The lesions</a:t>
            </a:r>
            <a:r>
              <a:rPr lang="en-US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K19-positiv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re characterized by the predominance of large fluid-filled cysts, known as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stodenomas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stocarcinomas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Original magnification: 20x; scale bar: 1000 </a:t>
            </a:r>
            <a:r>
              <a:rPr lang="de-DE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Abbreviation: H&amp;E, hematoxylin and eosin staining.</a:t>
            </a: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2403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Office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calAdmin</dc:creator>
  <cp:lastModifiedBy>Diego Calvisi</cp:lastModifiedBy>
  <cp:revision>28</cp:revision>
  <dcterms:created xsi:type="dcterms:W3CDTF">2024-07-10T12:09:23Z</dcterms:created>
  <dcterms:modified xsi:type="dcterms:W3CDTF">2024-08-14T15:03:53Z</dcterms:modified>
</cp:coreProperties>
</file>